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580" y="-4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22F6-90B5-4D7B-9FE0-80E66FC78C26}" type="datetimeFigureOut">
              <a:rPr lang="de-DE" smtClean="0"/>
              <a:pPr/>
              <a:t>19.08.2018</a:t>
            </a:fld>
            <a:endParaRPr lang="de-DE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AFD61-1E18-4216-BDA9-1E9D8B4020C1}" type="slidenum">
              <a:rPr lang="de-DE" smtClean="0"/>
              <a:pPr/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22F6-90B5-4D7B-9FE0-80E66FC78C26}" type="datetimeFigureOut">
              <a:rPr lang="de-DE" smtClean="0"/>
              <a:pPr/>
              <a:t>19.08.2018</a:t>
            </a:fld>
            <a:endParaRPr lang="de-DE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AFD61-1E18-4216-BDA9-1E9D8B4020C1}" type="slidenum">
              <a:rPr lang="de-DE" smtClean="0"/>
              <a:pPr/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22F6-90B5-4D7B-9FE0-80E66FC78C26}" type="datetimeFigureOut">
              <a:rPr lang="de-DE" smtClean="0"/>
              <a:pPr/>
              <a:t>19.08.2018</a:t>
            </a:fld>
            <a:endParaRPr lang="de-DE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AFD61-1E18-4216-BDA9-1E9D8B4020C1}" type="slidenum">
              <a:rPr lang="de-DE" smtClean="0"/>
              <a:pPr/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22F6-90B5-4D7B-9FE0-80E66FC78C26}" type="datetimeFigureOut">
              <a:rPr lang="de-DE" smtClean="0"/>
              <a:pPr/>
              <a:t>19.08.2018</a:t>
            </a:fld>
            <a:endParaRPr lang="de-DE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AFD61-1E18-4216-BDA9-1E9D8B4020C1}" type="slidenum">
              <a:rPr lang="de-DE" smtClean="0"/>
              <a:pPr/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22F6-90B5-4D7B-9FE0-80E66FC78C26}" type="datetimeFigureOut">
              <a:rPr lang="de-DE" smtClean="0"/>
              <a:pPr/>
              <a:t>19.08.2018</a:t>
            </a:fld>
            <a:endParaRPr lang="de-DE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AFD61-1E18-4216-BDA9-1E9D8B4020C1}" type="slidenum">
              <a:rPr lang="de-DE" smtClean="0"/>
              <a:pPr/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22F6-90B5-4D7B-9FE0-80E66FC78C26}" type="datetimeFigureOut">
              <a:rPr lang="de-DE" smtClean="0"/>
              <a:pPr/>
              <a:t>19.08.2018</a:t>
            </a:fld>
            <a:endParaRPr lang="de-DE" dirty="0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AFD61-1E18-4216-BDA9-1E9D8B4020C1}" type="slidenum">
              <a:rPr lang="de-DE" smtClean="0"/>
              <a:pPr/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22F6-90B5-4D7B-9FE0-80E66FC78C26}" type="datetimeFigureOut">
              <a:rPr lang="de-DE" smtClean="0"/>
              <a:pPr/>
              <a:t>19.08.2018</a:t>
            </a:fld>
            <a:endParaRPr lang="de-DE" dirty="0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AFD61-1E18-4216-BDA9-1E9D8B4020C1}" type="slidenum">
              <a:rPr lang="de-DE" smtClean="0"/>
              <a:pPr/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22F6-90B5-4D7B-9FE0-80E66FC78C26}" type="datetimeFigureOut">
              <a:rPr lang="de-DE" smtClean="0"/>
              <a:pPr/>
              <a:t>19.08.2018</a:t>
            </a:fld>
            <a:endParaRPr lang="de-DE" dirty="0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AFD61-1E18-4216-BDA9-1E9D8B4020C1}" type="slidenum">
              <a:rPr lang="de-DE" smtClean="0"/>
              <a:pPr/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22F6-90B5-4D7B-9FE0-80E66FC78C26}" type="datetimeFigureOut">
              <a:rPr lang="de-DE" smtClean="0"/>
              <a:pPr/>
              <a:t>19.08.2018</a:t>
            </a:fld>
            <a:endParaRPr lang="de-DE" dirty="0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AFD61-1E18-4216-BDA9-1E9D8B4020C1}" type="slidenum">
              <a:rPr lang="de-DE" smtClean="0"/>
              <a:pPr/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22F6-90B5-4D7B-9FE0-80E66FC78C26}" type="datetimeFigureOut">
              <a:rPr lang="de-DE" smtClean="0"/>
              <a:pPr/>
              <a:t>19.08.2018</a:t>
            </a:fld>
            <a:endParaRPr lang="de-DE" dirty="0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AFD61-1E18-4216-BDA9-1E9D8B4020C1}" type="slidenum">
              <a:rPr lang="de-DE" smtClean="0"/>
              <a:pPr/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 dirty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422F6-90B5-4D7B-9FE0-80E66FC78C26}" type="datetimeFigureOut">
              <a:rPr lang="de-DE" smtClean="0"/>
              <a:pPr/>
              <a:t>19.08.2018</a:t>
            </a:fld>
            <a:endParaRPr lang="de-DE" dirty="0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AFD61-1E18-4216-BDA9-1E9D8B4020C1}" type="slidenum">
              <a:rPr lang="de-DE" smtClean="0"/>
              <a:pPr/>
              <a:t>‹Nr.›</a:t>
            </a:fld>
            <a:endParaRPr lang="de-DE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1422F6-90B5-4D7B-9FE0-80E66FC78C26}" type="datetimeFigureOut">
              <a:rPr lang="de-DE" smtClean="0"/>
              <a:pPr/>
              <a:t>19.08.2018</a:t>
            </a:fld>
            <a:endParaRPr lang="de-DE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DAFD61-1E18-4216-BDA9-1E9D8B4020C1}" type="slidenum">
              <a:rPr lang="de-DE" smtClean="0"/>
              <a:pPr/>
              <a:t>‹Nr.›</a:t>
            </a:fld>
            <a:endParaRPr lang="de-DE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17"/>
          <p:cNvGrpSpPr/>
          <p:nvPr/>
        </p:nvGrpSpPr>
        <p:grpSpPr>
          <a:xfrm>
            <a:off x="620688" y="704528"/>
            <a:ext cx="2742882" cy="2107507"/>
            <a:chOff x="576649" y="1031748"/>
            <a:chExt cx="6759530" cy="4900139"/>
          </a:xfrm>
        </p:grpSpPr>
        <p:sp>
          <p:nvSpPr>
            <p:cNvPr id="5" name="Textfeld 4"/>
            <p:cNvSpPr txBox="1"/>
            <p:nvPr/>
          </p:nvSpPr>
          <p:spPr>
            <a:xfrm>
              <a:off x="576649" y="1031748"/>
              <a:ext cx="1246661" cy="6003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itchFamily="34" charset="0"/>
                  <a:cs typeface="Arial" pitchFamily="34" charset="0"/>
                </a:rPr>
                <a:t>MGO</a:t>
              </a:r>
              <a:endParaRPr lang="de-DE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931561" y="2888670"/>
              <a:ext cx="1167209" cy="6003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itchFamily="34" charset="0"/>
                  <a:cs typeface="Arial" pitchFamily="34" charset="0"/>
                </a:rPr>
                <a:t>GSH</a:t>
              </a:r>
              <a:endParaRPr lang="de-DE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3061030" y="2888670"/>
              <a:ext cx="4275149" cy="6440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itchFamily="34" charset="0"/>
                  <a:cs typeface="Arial" pitchFamily="34" charset="0"/>
                </a:rPr>
                <a:t>S-D-Lactoylglutathione</a:t>
              </a:r>
              <a:endParaRPr lang="de-DE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2113354" y="4100518"/>
              <a:ext cx="2643625" cy="644047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itchFamily="34" charset="0"/>
                  <a:cs typeface="Arial" pitchFamily="34" charset="0"/>
                </a:rPr>
                <a:t>Glyoxalase II</a:t>
              </a:r>
              <a:endParaRPr lang="de-DE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Nach unten gekrümmter Pfeil 8"/>
            <p:cNvSpPr/>
            <p:nvPr/>
          </p:nvSpPr>
          <p:spPr>
            <a:xfrm>
              <a:off x="1428728" y="2285992"/>
              <a:ext cx="3643338" cy="642942"/>
            </a:xfrm>
            <a:prstGeom prst="curvedDown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2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Nach unten gekrümmter Pfeil 9"/>
            <p:cNvSpPr/>
            <p:nvPr/>
          </p:nvSpPr>
          <p:spPr>
            <a:xfrm flipH="1" flipV="1">
              <a:off x="1357290" y="3429000"/>
              <a:ext cx="3643338" cy="642942"/>
            </a:xfrm>
            <a:prstGeom prst="curvedDown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2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Nach oben gekrümmter Pfeil 10"/>
            <p:cNvSpPr/>
            <p:nvPr/>
          </p:nvSpPr>
          <p:spPr>
            <a:xfrm>
              <a:off x="1285852" y="1571612"/>
              <a:ext cx="4643470" cy="714380"/>
            </a:xfrm>
            <a:prstGeom prst="curvedUp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2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 useBgFill="1">
          <p:nvSpPr>
            <p:cNvPr id="12" name="Ellipse 11"/>
            <p:cNvSpPr/>
            <p:nvPr/>
          </p:nvSpPr>
          <p:spPr>
            <a:xfrm>
              <a:off x="2883574" y="1428737"/>
              <a:ext cx="4143403" cy="928693"/>
            </a:xfrm>
            <a:prstGeom prst="ellips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2113354" y="1381848"/>
              <a:ext cx="2536963" cy="644047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itchFamily="34" charset="0"/>
                  <a:cs typeface="Arial" pitchFamily="34" charset="0"/>
                </a:rPr>
                <a:t>Glyoxalase I</a:t>
              </a:r>
              <a:endParaRPr lang="de-DE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Nach unten gekrümmter Pfeil 13"/>
            <p:cNvSpPr/>
            <p:nvPr/>
          </p:nvSpPr>
          <p:spPr>
            <a:xfrm flipH="1">
              <a:off x="1357291" y="4755009"/>
              <a:ext cx="3643339" cy="642943"/>
            </a:xfrm>
            <a:prstGeom prst="curvedDown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2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4479323" y="5287840"/>
              <a:ext cx="1066088" cy="6003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itchFamily="34" charset="0"/>
                  <a:cs typeface="Arial" pitchFamily="34" charset="0"/>
                </a:rPr>
                <a:t>H</a:t>
              </a:r>
              <a:r>
                <a:rPr lang="de-DE" sz="1200" baseline="-25000" dirty="0" smtClean="0">
                  <a:latin typeface="Arial" pitchFamily="34" charset="0"/>
                  <a:cs typeface="Arial" pitchFamily="34" charset="0"/>
                </a:rPr>
                <a:t>2</a:t>
              </a:r>
              <a:r>
                <a:rPr lang="de-DE" sz="1200" dirty="0" smtClean="0">
                  <a:latin typeface="Arial" pitchFamily="34" charset="0"/>
                  <a:cs typeface="Arial" pitchFamily="34" charset="0"/>
                </a:rPr>
                <a:t>O</a:t>
              </a:r>
              <a:endParaRPr lang="de-DE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576649" y="5287840"/>
              <a:ext cx="2094517" cy="6440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itchFamily="34" charset="0"/>
                  <a:cs typeface="Arial" pitchFamily="34" charset="0"/>
                </a:rPr>
                <a:t>D-Lactate</a:t>
              </a:r>
              <a:endParaRPr lang="de-DE" sz="12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7" name="Textfeld 16"/>
          <p:cNvSpPr txBox="1"/>
          <p:nvPr/>
        </p:nvSpPr>
        <p:spPr>
          <a:xfrm>
            <a:off x="0" y="0"/>
            <a:ext cx="24928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 smtClean="0">
                <a:latin typeface="Arial" pitchFamily="34" charset="0"/>
                <a:cs typeface="Arial" pitchFamily="34" charset="0"/>
              </a:rPr>
              <a:t>Supplemental</a:t>
            </a:r>
            <a:r>
              <a:rPr lang="de-DE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b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de-DE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b="1" dirty="0" smtClean="0">
                <a:latin typeface="Arial" pitchFamily="34" charset="0"/>
                <a:cs typeface="Arial" pitchFamily="34" charset="0"/>
              </a:rPr>
              <a:t>1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</Words>
  <Application>Microsoft Office PowerPoint</Application>
  <PresentationFormat>A4-Papier (210x297 mm)</PresentationFormat>
  <Paragraphs>8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Marcus Hollenbach</dc:creator>
  <cp:lastModifiedBy>Marcus Hollenbach</cp:lastModifiedBy>
  <cp:revision>4</cp:revision>
  <dcterms:created xsi:type="dcterms:W3CDTF">2015-09-18T18:10:03Z</dcterms:created>
  <dcterms:modified xsi:type="dcterms:W3CDTF">2018-08-19T13:40:04Z</dcterms:modified>
</cp:coreProperties>
</file>